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670675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24EE11-1F0A-40E5-88B9-4A55D74B2FC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C88646-4B97-428D-B90B-892B316A3FB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EC6EA1-2692-47DE-AA5A-D1D4BB02E00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59FC8C-F7BC-42AD-86DC-E5D63AC2F5E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B10097-3A1E-4BAC-A192-2F6B963564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E07635-1060-4C1E-8087-5D89CAD6D5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238A2F-8122-422A-B504-DDC64213CED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7E7176-A7D9-4946-9379-033709F1BF5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F409D1-8013-4FB9-A6D0-055B8FDD724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6B9529-F767-44D0-81A4-53562CC6D6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945C18-5907-4D88-B8F7-B9B907EDAD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370731-0F75-4ADE-A437-0CCEAF8733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152C01B-B2D4-4064-BD3D-B6E145C0DD8D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"/>
          <p:cNvPicPr/>
          <p:nvPr/>
        </p:nvPicPr>
        <p:blipFill>
          <a:blip r:embed="rId1"/>
          <a:stretch/>
        </p:blipFill>
        <p:spPr>
          <a:xfrm>
            <a:off x="2603520" y="3487680"/>
            <a:ext cx="1361880" cy="165276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5" descr=""/>
          <p:cNvPicPr/>
          <p:nvPr/>
        </p:nvPicPr>
        <p:blipFill>
          <a:blip r:embed="rId2"/>
          <a:stretch/>
        </p:blipFill>
        <p:spPr>
          <a:xfrm>
            <a:off x="2603520" y="5359320"/>
            <a:ext cx="1361880" cy="63972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6" descr=""/>
          <p:cNvPicPr/>
          <p:nvPr/>
        </p:nvPicPr>
        <p:blipFill>
          <a:blip r:embed="rId3"/>
          <a:stretch/>
        </p:blipFill>
        <p:spPr>
          <a:xfrm>
            <a:off x="2603520" y="6215040"/>
            <a:ext cx="1361880" cy="550800"/>
          </a:xfrm>
          <a:prstGeom prst="rect">
            <a:avLst/>
          </a:prstGeom>
          <a:ln w="0">
            <a:noFill/>
          </a:ln>
        </p:spPr>
      </p:pic>
      <p:sp>
        <p:nvSpPr>
          <p:cNvPr id="44" name="TextBox 7"/>
          <p:cNvSpPr/>
          <p:nvPr/>
        </p:nvSpPr>
        <p:spPr>
          <a:xfrm rot="16200000">
            <a:off x="2693520" y="2985840"/>
            <a:ext cx="714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F.NPHP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8"/>
          <p:cNvSpPr/>
          <p:nvPr/>
        </p:nvSpPr>
        <p:spPr>
          <a:xfrm rot="16200000">
            <a:off x="2824200" y="2850480"/>
            <a:ext cx="944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F.NPHP7</a:t>
            </a:r>
            <a:r>
              <a:rPr b="0" lang="de-DE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C175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9"/>
          <p:cNvSpPr/>
          <p:nvPr/>
        </p:nvSpPr>
        <p:spPr>
          <a:xfrm rot="16200000">
            <a:off x="2826360" y="2628360"/>
            <a:ext cx="1438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F.NPHP7 + V5.BBS1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10"/>
          <p:cNvSpPr/>
          <p:nvPr/>
        </p:nvSpPr>
        <p:spPr>
          <a:xfrm rot="16200000">
            <a:off x="2965320" y="2490120"/>
            <a:ext cx="1652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F.NPHP7</a:t>
            </a:r>
            <a:r>
              <a:rPr b="0" lang="de-DE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C175R </a:t>
            </a: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+ V5.BBS1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 Box 13"/>
          <p:cNvSpPr/>
          <p:nvPr/>
        </p:nvSpPr>
        <p:spPr>
          <a:xfrm>
            <a:off x="2533680" y="6729480"/>
            <a:ext cx="126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de-DE" sz="1000" spc="-1" strike="noStrike">
                <a:solidFill>
                  <a:srgbClr val="000000"/>
                </a:solidFill>
                <a:latin typeface="Arial"/>
              </a:rPr>
              <a:t>Lysates: anti-V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 Box 13"/>
          <p:cNvSpPr/>
          <p:nvPr/>
        </p:nvSpPr>
        <p:spPr>
          <a:xfrm>
            <a:off x="2533680" y="5081760"/>
            <a:ext cx="1882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de-DE" sz="1000" spc="-1" strike="noStrike">
                <a:solidFill>
                  <a:srgbClr val="000000"/>
                </a:solidFill>
                <a:latin typeface="Arial"/>
              </a:rPr>
              <a:t>IP: anti-Flag, WB: anti-H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 Box 13"/>
          <p:cNvSpPr/>
          <p:nvPr/>
        </p:nvSpPr>
        <p:spPr>
          <a:xfrm>
            <a:off x="2533680" y="5964120"/>
            <a:ext cx="1882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de-DE" sz="1000" spc="-1" strike="noStrike">
                <a:solidFill>
                  <a:srgbClr val="000000"/>
                </a:solidFill>
                <a:latin typeface="Arial"/>
              </a:rPr>
              <a:t>IP: anti-Flag, WB: anti-FLA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4"/>
          <p:cNvSpPr/>
          <p:nvPr/>
        </p:nvSpPr>
        <p:spPr>
          <a:xfrm rot="16200000">
            <a:off x="2489760" y="307152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Vecto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Straight Connector 15"/>
          <p:cNvSpPr/>
          <p:nvPr/>
        </p:nvSpPr>
        <p:spPr>
          <a:xfrm>
            <a:off x="2538360" y="1674720"/>
            <a:ext cx="13129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7"/>
          <p:cNvSpPr/>
          <p:nvPr/>
        </p:nvSpPr>
        <p:spPr>
          <a:xfrm>
            <a:off x="2695320" y="1415880"/>
            <a:ext cx="1047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HA.ubiquit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8"/>
          <p:cNvSpPr/>
          <p:nvPr/>
        </p:nvSpPr>
        <p:spPr>
          <a:xfrm>
            <a:off x="2209680" y="3257640"/>
            <a:ext cx="406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kD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19"/>
          <p:cNvSpPr/>
          <p:nvPr/>
        </p:nvSpPr>
        <p:spPr>
          <a:xfrm>
            <a:off x="2288160" y="4602240"/>
            <a:ext cx="398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75 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20"/>
          <p:cNvSpPr/>
          <p:nvPr/>
        </p:nvSpPr>
        <p:spPr>
          <a:xfrm>
            <a:off x="2217600" y="3614760"/>
            <a:ext cx="468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250 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21"/>
          <p:cNvSpPr/>
          <p:nvPr/>
        </p:nvSpPr>
        <p:spPr>
          <a:xfrm>
            <a:off x="2288160" y="5481720"/>
            <a:ext cx="398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75 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22"/>
          <p:cNvSpPr/>
          <p:nvPr/>
        </p:nvSpPr>
        <p:spPr>
          <a:xfrm>
            <a:off x="2288160" y="6467400"/>
            <a:ext cx="398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75 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Right Brace 23"/>
          <p:cNvSpPr/>
          <p:nvPr/>
        </p:nvSpPr>
        <p:spPr>
          <a:xfrm>
            <a:off x="4044960" y="3701880"/>
            <a:ext cx="158760" cy="1111320"/>
          </a:xfrm>
          <a:custGeom>
            <a:avLst/>
            <a:gdLst>
              <a:gd name="textAreaLeft" fmla="*/ 0 w 158760"/>
              <a:gd name="textAreaRight" fmla="*/ 57240 w 158760"/>
              <a:gd name="textAreaTop" fmla="*/ 3960 h 1111320"/>
              <a:gd name="textAreaBottom" fmla="*/ 1107360 h 11113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29"/>
                  <a:pt x="10800" y="258"/>
                </a:cubicBezTo>
                <a:lnTo>
                  <a:pt x="10800" y="10542"/>
                </a:lnTo>
                <a:cubicBezTo>
                  <a:pt x="10800" y="10671"/>
                  <a:pt x="16200" y="10800"/>
                  <a:pt x="21600" y="10800"/>
                </a:cubicBezTo>
                <a:cubicBezTo>
                  <a:pt x="16200" y="10800"/>
                  <a:pt x="10800" y="10929"/>
                  <a:pt x="10800" y="11058"/>
                </a:cubicBezTo>
                <a:lnTo>
                  <a:pt x="10800" y="21342"/>
                </a:lnTo>
                <a:cubicBezTo>
                  <a:pt x="10800" y="21471"/>
                  <a:pt x="5400" y="21600"/>
                  <a:pt x="0" y="21600"/>
                </a:cubicBezTo>
              </a:path>
            </a:pathLst>
          </a:cu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24"/>
          <p:cNvSpPr/>
          <p:nvPr/>
        </p:nvSpPr>
        <p:spPr>
          <a:xfrm>
            <a:off x="4199040" y="4130640"/>
            <a:ext cx="83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Ubi-NPHP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15"/>
          <p:cNvSpPr/>
          <p:nvPr/>
        </p:nvSpPr>
        <p:spPr>
          <a:xfrm>
            <a:off x="3923640" y="5662440"/>
            <a:ext cx="79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- F.NPHP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15"/>
          <p:cNvSpPr/>
          <p:nvPr/>
        </p:nvSpPr>
        <p:spPr>
          <a:xfrm>
            <a:off x="3922920" y="6435720"/>
            <a:ext cx="83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- V5.BBS1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feld 3"/>
          <p:cNvSpPr/>
          <p:nvPr/>
        </p:nvSpPr>
        <p:spPr>
          <a:xfrm>
            <a:off x="509760" y="428760"/>
            <a:ext cx="323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. Figure 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9-19T08:24:20Z</dcterms:created>
  <dc:creator>Gerd Walz</dc:creator>
  <dc:description/>
  <dc:language>en-US</dc:language>
  <cp:lastModifiedBy>ravikumar.n</cp:lastModifiedBy>
  <cp:lastPrinted>2015-01-26T13:44:50Z</cp:lastPrinted>
  <dcterms:modified xsi:type="dcterms:W3CDTF">2015-09-02T12:30:16Z</dcterms:modified>
  <cp:revision>421</cp:revision>
  <dc:subject/>
  <dc:title>PowerPoint-Präsentation</dc:title>
</cp:coreProperties>
</file>